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4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 xmlns:mv="urn:schemas-microsoft-com:mac:vml" xmlns:mc="http://schemas.openxmlformats.org/markup-compatibility/2006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Nishi Akinori" initials="" lastIdx="33" clrIdx="0"/>
  <p:cmAuthor id="1" name="首藤 隆秀" initials="首藤" lastIdx="26" clrIdx="1"/>
  <p:cmAuthor id="2" name="西 昭徳" initials="" lastIdx="33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C6DBF1"/>
    <a:srgbClr val="FF7C7B"/>
    <a:srgbClr val="F3DBD5"/>
    <a:srgbClr val="FF4F00"/>
    <a:srgbClr val="919191"/>
    <a:srgbClr val="009B33"/>
    <a:srgbClr val="008E1D"/>
    <a:srgbClr val="008000"/>
    <a:srgbClr val="91DBF2"/>
    <a:srgbClr val="143D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xmlns:mv="urn:schemas-microsoft-com:mac:vml" xmlns:mc="http://schemas.openxmlformats.org/markup-compatibility/2006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113" autoAdjust="0"/>
    <p:restoredTop sz="99430" autoAdjust="0"/>
  </p:normalViewPr>
  <p:slideViewPr>
    <p:cSldViewPr snapToGrid="0" snapToObjects="1">
      <p:cViewPr varScale="1">
        <p:scale>
          <a:sx n="146" d="100"/>
          <a:sy n="146" d="100"/>
        </p:scale>
        <p:origin x="-3760" y="-11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34A064-C76C-F940-961E-57D5F8375C2F}" type="datetimeFigureOut">
              <a:rPr lang="ja-JP" altLang="en-US" smtClean="0"/>
              <a:pPr/>
              <a:t>18/10/1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27198C-4FBF-014B-8572-DF7DB85B7F2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FLX_D1R_Fig7_20170412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445" y="1436779"/>
            <a:ext cx="6054405" cy="4539907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194735" y="6156528"/>
            <a:ext cx="6479998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Supplementary Figure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11.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Scheme </a:t>
            </a:r>
            <a:r>
              <a:rPr lang="en-US" altLang="ja-JP" sz="1200" b="1" dirty="0">
                <a:solidFill>
                  <a:srgbClr val="000000"/>
                </a:solidFill>
                <a:latin typeface="Times New Roman"/>
                <a:cs typeface="Times New Roman"/>
              </a:rPr>
              <a:t>illustrating the role of D1 receptors in the action of antidepressants in the dentate gyrus.</a:t>
            </a:r>
            <a:endParaRPr lang="ja-JP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algn="just"/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Chronic administration of fluoxetine, an inhibitor of the serotonin transporter (SERT), increases the extracellular levels of 5-HT, leading to activation of 5-HT neurotransmission including 5-HT4 receptor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(5-HT</a:t>
            </a:r>
            <a:r>
              <a:rPr lang="en-US" altLang="ja-JP" sz="1200" baseline="-250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4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R) signaling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in the dentate gyrus. Chronic fluoxetine probably via upregulation of 5-HT neurotransmission induces an increase in D1 receptors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(D</a:t>
            </a:r>
            <a:r>
              <a:rPr lang="en-US" altLang="ja-JP" sz="1200" baseline="-250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1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R)</a:t>
            </a:r>
            <a:r>
              <a:rPr lang="ja-JP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and 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decreases in calbindin and tryptophan-2,3-dioxygenase (TDO2) in mature granule cells. D1 receptors are activated by endogenous dopamine (DA) released from terminals of neurons in the ventral tegmental area (VTA) and locus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coeruleus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(LC).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Upregulation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of D1 receptor signaling in the dentate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gyrus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enhances antidepressant effects on depression-like behaviors via several mechanisms: (1) increased excitability and synaptic transmission of mature granule cells, (2) increased adult neurogenesis in the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subgranular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zone, and (3) decreased 5-HT response to novelty stress. Under severely stressed conditions, antidepressants fail to enhance D1 receptor signaling and improve depression-like behaviors. However, co-administration of the D1 receptor agonist improves therapeutic efficacy of fluoxetine. NA, noradrenaline.</a:t>
            </a:r>
            <a:endParaRPr lang="ja-JP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88938375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92</TotalTime>
  <Words>235</Words>
  <Application>Microsoft Macintosh PowerPoint</Application>
  <PresentationFormat>A4 210x297 mm</PresentationFormat>
  <Paragraphs>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subject/>
  <dc:creator>首藤 隆秀</dc:creator>
  <cp:keywords/>
  <dc:description/>
  <cp:lastModifiedBy>西 昭徳</cp:lastModifiedBy>
  <cp:revision>672</cp:revision>
  <cp:lastPrinted>2018-06-26T10:35:07Z</cp:lastPrinted>
  <dcterms:created xsi:type="dcterms:W3CDTF">2018-10-09T04:30:15Z</dcterms:created>
  <dcterms:modified xsi:type="dcterms:W3CDTF">2018-10-11T02:28:19Z</dcterms:modified>
  <cp:category/>
</cp:coreProperties>
</file>